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6800850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2ACDB-9AC5-479E-B4A9-F9699CBEAF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6521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8760" y="6389640"/>
            <a:ext cx="6521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185D6-697F-4EA3-B83A-C3DBA9135E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876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064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BB484-3DA6-441F-BC09-80169E7627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23760" y="284652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28400" y="284652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8760" y="638964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23760" y="638964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28400" y="6389640"/>
            <a:ext cx="20995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5814F-6367-4DE1-AEFF-D11DBBEB50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8760" y="2846520"/>
            <a:ext cx="6521400" cy="6783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25"/>
              </a:spcBef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47EED-D416-4614-82EF-58787D2165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6521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AAB57-C62B-4216-B08D-C7C339204D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9824E-B943-44A5-9ED7-D420E07D9E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31D94-A47E-47FE-8F1C-2346DD18CB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8760" y="569520"/>
            <a:ext cx="6521400" cy="957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A1890-EE94-4D37-80CA-7BA3FD4B99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876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01E8B-852C-4CF0-BB17-D0B97E073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0640" y="638964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827C0-D9F5-430E-9FA2-E042E8ED01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876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0640" y="2846520"/>
            <a:ext cx="3182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8760" y="6389640"/>
            <a:ext cx="65214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AE618-7627-4A22-A9BD-E06E1652DC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8760" y="569520"/>
            <a:ext cx="65214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8760" y="2846520"/>
            <a:ext cx="65214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900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6664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94464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32228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8760" y="9909000"/>
            <a:ext cx="170172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03080" y="9909000"/>
            <a:ext cx="255276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338440" y="9909000"/>
            <a:ext cx="170172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E2CC322-7530-4B37-9617-83574AFAB672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phique 4" descr=""/>
          <p:cNvPicPr/>
          <p:nvPr/>
        </p:nvPicPr>
        <p:blipFill>
          <a:blip r:embed="rId1"/>
          <a:stretch/>
        </p:blipFill>
        <p:spPr>
          <a:xfrm>
            <a:off x="2924280" y="3627360"/>
            <a:ext cx="2797200" cy="3746520"/>
          </a:xfrm>
          <a:prstGeom prst="rect">
            <a:avLst/>
          </a:prstGeom>
          <a:ln w="0">
            <a:noFill/>
          </a:ln>
        </p:spPr>
      </p:pic>
      <p:pic>
        <p:nvPicPr>
          <p:cNvPr id="42" name="Graphique 5" descr=""/>
          <p:cNvPicPr/>
          <p:nvPr/>
        </p:nvPicPr>
        <p:blipFill>
          <a:blip r:embed="rId2"/>
          <a:stretch/>
        </p:blipFill>
        <p:spPr>
          <a:xfrm>
            <a:off x="76320" y="3627360"/>
            <a:ext cx="2790720" cy="3746520"/>
          </a:xfrm>
          <a:prstGeom prst="rect">
            <a:avLst/>
          </a:prstGeom>
          <a:ln w="0">
            <a:noFill/>
          </a:ln>
        </p:spPr>
      </p:pic>
      <p:sp>
        <p:nvSpPr>
          <p:cNvPr id="43" name="ZoneTexte 6"/>
          <p:cNvSpPr/>
          <p:nvPr/>
        </p:nvSpPr>
        <p:spPr>
          <a:xfrm>
            <a:off x="3079800" y="6769080"/>
            <a:ext cx="24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unded projec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7"/>
          <p:cNvSpPr/>
          <p:nvPr/>
        </p:nvSpPr>
        <p:spPr>
          <a:xfrm>
            <a:off x="133200" y="6769080"/>
            <a:ext cx="248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ubmitted projec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Groupe 8"/>
          <p:cNvGrpSpPr/>
          <p:nvPr/>
        </p:nvGrpSpPr>
        <p:grpSpPr>
          <a:xfrm>
            <a:off x="5778360" y="4184640"/>
            <a:ext cx="1838520" cy="2288520"/>
            <a:chOff x="5778360" y="4184640"/>
            <a:chExt cx="1838520" cy="2288520"/>
          </a:xfrm>
        </p:grpSpPr>
        <p:sp>
          <p:nvSpPr>
            <p:cNvPr id="46" name="Rectangle 9"/>
            <p:cNvSpPr/>
            <p:nvPr/>
          </p:nvSpPr>
          <p:spPr>
            <a:xfrm>
              <a:off x="5877720" y="4184640"/>
              <a:ext cx="1739160" cy="228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Cardiology/Vascular Diseas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Dermat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Dysmorph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Endocrin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Gastroenter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Hematology/Immun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Metabolic diseas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Musculoskeletal Diseas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ephrology/Ur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eur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Ophthalm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Other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Otolaryng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Psychiatry/Psych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Pulmonary/Respiratory Diseas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Rheumatolog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Ellipse 10"/>
            <p:cNvSpPr/>
            <p:nvPr/>
          </p:nvSpPr>
          <p:spPr>
            <a:xfrm>
              <a:off x="5780520" y="4254120"/>
              <a:ext cx="99360" cy="73080"/>
            </a:xfrm>
            <a:prstGeom prst="ellipse">
              <a:avLst/>
            </a:prstGeom>
            <a:solidFill>
              <a:srgbClr val="0b6fc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Ellipse 11"/>
            <p:cNvSpPr/>
            <p:nvPr/>
          </p:nvSpPr>
          <p:spPr>
            <a:xfrm>
              <a:off x="5780520" y="4392720"/>
              <a:ext cx="99360" cy="73080"/>
            </a:xfrm>
            <a:prstGeom prst="ellipse">
              <a:avLst/>
            </a:prstGeom>
            <a:solidFill>
              <a:srgbClr val="009dd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Ellipse 12"/>
            <p:cNvSpPr/>
            <p:nvPr/>
          </p:nvSpPr>
          <p:spPr>
            <a:xfrm>
              <a:off x="5780520" y="4531320"/>
              <a:ext cx="99360" cy="73080"/>
            </a:xfrm>
            <a:prstGeom prst="ellipse">
              <a:avLst/>
            </a:prstGeom>
            <a:solidFill>
              <a:srgbClr val="0bd0d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Ellipse 13"/>
            <p:cNvSpPr/>
            <p:nvPr/>
          </p:nvSpPr>
          <p:spPr>
            <a:xfrm>
              <a:off x="5780520" y="4669920"/>
              <a:ext cx="99360" cy="73080"/>
            </a:xfrm>
            <a:prstGeom prst="ellipse">
              <a:avLst/>
            </a:prstGeom>
            <a:solidFill>
              <a:srgbClr val="0bab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Ellipse 14"/>
            <p:cNvSpPr/>
            <p:nvPr/>
          </p:nvSpPr>
          <p:spPr>
            <a:xfrm>
              <a:off x="5780520" y="4808520"/>
              <a:ext cx="99360" cy="73080"/>
            </a:xfrm>
            <a:prstGeom prst="ellipse">
              <a:avLst/>
            </a:prstGeom>
            <a:solidFill>
              <a:srgbClr val="6ab43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Ellipse 15"/>
            <p:cNvSpPr/>
            <p:nvPr/>
          </p:nvSpPr>
          <p:spPr>
            <a:xfrm>
              <a:off x="5780520" y="4947120"/>
              <a:ext cx="99360" cy="73080"/>
            </a:xfrm>
            <a:prstGeom prst="ellipse">
              <a:avLst/>
            </a:prstGeom>
            <a:solidFill>
              <a:srgbClr val="a5c24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Ellipse 16"/>
            <p:cNvSpPr/>
            <p:nvPr/>
          </p:nvSpPr>
          <p:spPr>
            <a:xfrm>
              <a:off x="5780520" y="5085720"/>
              <a:ext cx="99360" cy="73080"/>
            </a:xfrm>
            <a:prstGeom prst="ellipse">
              <a:avLst/>
            </a:prstGeom>
            <a:solidFill>
              <a:srgbClr val="66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Ellipse 17"/>
            <p:cNvSpPr/>
            <p:nvPr/>
          </p:nvSpPr>
          <p:spPr>
            <a:xfrm>
              <a:off x="5780520" y="5223960"/>
              <a:ext cx="99360" cy="73080"/>
            </a:xfrm>
            <a:prstGeom prst="ellipse">
              <a:avLst/>
            </a:prstGeom>
            <a:solidFill>
              <a:srgbClr val="91c6f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Ellipse 18"/>
            <p:cNvSpPr/>
            <p:nvPr/>
          </p:nvSpPr>
          <p:spPr>
            <a:xfrm>
              <a:off x="5780520" y="5362560"/>
              <a:ext cx="99360" cy="73080"/>
            </a:xfrm>
            <a:prstGeom prst="ellipse">
              <a:avLst/>
            </a:prstGeom>
            <a:solidFill>
              <a:srgbClr val="95f7d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Ellipse 19"/>
            <p:cNvSpPr/>
            <p:nvPr/>
          </p:nvSpPr>
          <p:spPr>
            <a:xfrm>
              <a:off x="5780520" y="5501160"/>
              <a:ext cx="99360" cy="73080"/>
            </a:xfrm>
            <a:prstGeom prst="ellipse">
              <a:avLst/>
            </a:prstGeom>
            <a:solidFill>
              <a:srgbClr val="918f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Ellipse 20"/>
            <p:cNvSpPr/>
            <p:nvPr/>
          </p:nvSpPr>
          <p:spPr>
            <a:xfrm>
              <a:off x="5780520" y="5639760"/>
              <a:ext cx="99360" cy="73080"/>
            </a:xfrm>
            <a:prstGeom prst="ellipse">
              <a:avLst/>
            </a:prstGeom>
            <a:solidFill>
              <a:srgbClr val="233d5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Ellipse 21"/>
            <p:cNvSpPr/>
            <p:nvPr/>
          </p:nvSpPr>
          <p:spPr>
            <a:xfrm>
              <a:off x="5780520" y="5778360"/>
              <a:ext cx="99360" cy="73080"/>
            </a:xfrm>
            <a:prstGeom prst="ellipse">
              <a:avLst/>
            </a:prstGeom>
            <a:solidFill>
              <a:srgbClr val="2bb0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Ellipse 22"/>
            <p:cNvSpPr/>
            <p:nvPr/>
          </p:nvSpPr>
          <p:spPr>
            <a:xfrm>
              <a:off x="5778360" y="5916960"/>
              <a:ext cx="99360" cy="73080"/>
            </a:xfrm>
            <a:prstGeom prst="ellipse">
              <a:avLst/>
            </a:prstGeom>
            <a:solidFill>
              <a:srgbClr val="8cb5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Ellipse 23"/>
            <p:cNvSpPr/>
            <p:nvPr/>
          </p:nvSpPr>
          <p:spPr>
            <a:xfrm>
              <a:off x="5778360" y="6055560"/>
              <a:ext cx="99360" cy="73080"/>
            </a:xfrm>
            <a:prstGeom prst="ellipse">
              <a:avLst/>
            </a:prstGeom>
            <a:solidFill>
              <a:srgbClr val="d4d4d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Ellipse 24"/>
            <p:cNvSpPr/>
            <p:nvPr/>
          </p:nvSpPr>
          <p:spPr>
            <a:xfrm>
              <a:off x="5778360" y="6194160"/>
              <a:ext cx="99360" cy="73080"/>
            </a:xfrm>
            <a:prstGeom prst="ellipse">
              <a:avLst/>
            </a:prstGeom>
            <a:solidFill>
              <a:srgbClr val="a0e2e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Ellipse 25"/>
            <p:cNvSpPr/>
            <p:nvPr/>
          </p:nvSpPr>
          <p:spPr>
            <a:xfrm>
              <a:off x="5778360" y="6332400"/>
              <a:ext cx="99360" cy="73080"/>
            </a:xfrm>
            <a:prstGeom prst="ellipse">
              <a:avLst/>
            </a:prstGeom>
            <a:solidFill>
              <a:srgbClr val="a0e1c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" name="ZoneTexte 26"/>
          <p:cNvSpPr/>
          <p:nvPr/>
        </p:nvSpPr>
        <p:spPr>
          <a:xfrm>
            <a:off x="266760" y="3627360"/>
            <a:ext cx="274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4T14:51:29Z</dcterms:created>
  <dc:creator>HALFTERMEYER Juliane</dc:creator>
  <dc:description/>
  <dc:language>en-US</dc:language>
  <cp:lastModifiedBy>vidya.p</cp:lastModifiedBy>
  <cp:lastPrinted>2017-02-14T17:40:39Z</cp:lastPrinted>
  <dcterms:modified xsi:type="dcterms:W3CDTF">2017-09-22T11:57:49Z</dcterms:modified>
  <cp:revision>38</cp:revision>
  <dc:subject/>
  <dc:title>Présentation PowerPoint</dc:title>
</cp:coreProperties>
</file>